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17" d="100"/>
          <a:sy n="117" d="100"/>
        </p:scale>
        <p:origin x="-72" y="1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1044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5045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8372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13432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5290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0448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2653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9487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5169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3336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2452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EEC44-CDFB-4B4E-9F50-99DA06B6D71A}" type="datetimeFigureOut">
              <a:rPr lang="en-GB" smtClean="0"/>
              <a:t>14/0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35FE1A-F7E7-4BDE-9D6D-F58FB48FDE38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2025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7838"/>
            <a:ext cx="12192000" cy="441352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6211669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ure 4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–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vi’O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ots displaying the clustering patterns of assembled contig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ong with their coverage by each metagenome. Leftmost graph shows the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ig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lustered only by sequence composition (i.e. tetrameric signature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;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most graph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uster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ntigs only by their differential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verage; middle graph, combinatio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differential coverage and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trameric</a:t>
            </a:r>
            <a:r>
              <a:rPr lang="en-GB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osition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203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Personalizzat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posito, Alfonso</dc:creator>
  <cp:lastModifiedBy>Olivier Jousson</cp:lastModifiedBy>
  <cp:revision>4</cp:revision>
  <dcterms:created xsi:type="dcterms:W3CDTF">2018-06-20T12:17:21Z</dcterms:created>
  <dcterms:modified xsi:type="dcterms:W3CDTF">2018-09-14T12:46:29Z</dcterms:modified>
</cp:coreProperties>
</file>